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drawings/drawing1.xml" ContentType="application/vnd.openxmlformats-officedocument.drawingml.chartshape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61"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2659" autoAdjust="0"/>
  </p:normalViewPr>
  <p:slideViewPr>
    <p:cSldViewPr snapToGrid="0" snapToObjects="1">
      <p:cViewPr>
        <p:scale>
          <a:sx n="100" d="100"/>
          <a:sy n="100" d="100"/>
        </p:scale>
        <p:origin x="-1264" y="-176"/>
      </p:cViewPr>
      <p:guideLst>
        <p:guide orient="horz" pos="243"/>
        <p:guide/>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4" Type="http://schemas.openxmlformats.org/officeDocument/2006/relationships/printerSettings" Target="printerSettings/printerSettings1.bin"/><Relationship Id="rId5" Type="http://schemas.openxmlformats.org/officeDocument/2006/relationships/presProps" Target="presProps.xml"/><Relationship Id="rId6" Type="http://schemas.openxmlformats.org/officeDocument/2006/relationships/viewProps" Target="viewProps.xml"/><Relationship Id="rId7" Type="http://schemas.openxmlformats.org/officeDocument/2006/relationships/theme" Target="theme/theme1.xml"/><Relationship Id="rId8"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charts/_rels/chart1.xml.rels><?xml version="1.0" encoding="UTF-8" standalone="yes"?>
<Relationships xmlns="http://schemas.openxmlformats.org/package/2006/relationships"><Relationship Id="rId1" Type="http://schemas.openxmlformats.org/officeDocument/2006/relationships/oleObject" Target="hort$:Lin%20Tian:Documents:RNAseq.latest.analysis:GOseq.result.of.photo.DE.genes.0417.xlsx" TargetMode="External"/><Relationship Id="rId2" Type="http://schemas.openxmlformats.org/officeDocument/2006/relationships/chartUserShapes" Target="../drawings/drawing1.xml"/></Relationships>
</file>

<file path=ppt/charts/chart1.xml><?xml version="1.0" encoding="utf-8"?>
<c:chartSpace xmlns:c="http://schemas.openxmlformats.org/drawingml/2006/chart" xmlns:a="http://schemas.openxmlformats.org/drawingml/2006/main" xmlns:r="http://schemas.openxmlformats.org/officeDocument/2006/relationships">
  <c:date1904 val="1"/>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342693788276465"/>
          <c:y val="0.0601851851851852"/>
          <c:w val="0.618729877515311"/>
          <c:h val="0.822469378827647"/>
        </c:manualLayout>
      </c:layout>
      <c:barChart>
        <c:barDir val="bar"/>
        <c:grouping val="clustered"/>
        <c:varyColors val="0"/>
        <c:ser>
          <c:idx val="0"/>
          <c:order val="0"/>
          <c:tx>
            <c:v>ratio in DE genes</c:v>
          </c:tx>
          <c:invertIfNegative val="0"/>
          <c:cat>
            <c:strRef>
              <c:f>MF!$H$1:$H$20</c:f>
              <c:strCache>
                <c:ptCount val="20"/>
                <c:pt idx="0">
                  <c:v>ATP binding</c:v>
                </c:pt>
                <c:pt idx="1">
                  <c:v>protein binding</c:v>
                </c:pt>
                <c:pt idx="2">
                  <c:v>zinc ion binding</c:v>
                </c:pt>
                <c:pt idx="3">
                  <c:v>nucleotide binding</c:v>
                </c:pt>
                <c:pt idx="4">
                  <c:v>protein serine/threonine kinase activity</c:v>
                </c:pt>
                <c:pt idx="5">
                  <c:v>sequence-specific DNA binding transcription factor activity</c:v>
                </c:pt>
                <c:pt idx="6">
                  <c:v>copper ion binding</c:v>
                </c:pt>
                <c:pt idx="7">
                  <c:v>DNA binding</c:v>
                </c:pt>
                <c:pt idx="8">
                  <c:v>receptor activity</c:v>
                </c:pt>
                <c:pt idx="9">
                  <c:v>electron carrier activity</c:v>
                </c:pt>
                <c:pt idx="10">
                  <c:v>RNA binding</c:v>
                </c:pt>
                <c:pt idx="11">
                  <c:v>calcium ion binding</c:v>
                </c:pt>
                <c:pt idx="12">
                  <c:v>2-alkenal reductase [NAD(P)] activity</c:v>
                </c:pt>
                <c:pt idx="13">
                  <c:v>GTP binding</c:v>
                </c:pt>
                <c:pt idx="14">
                  <c:v>protein tyrosine kinase activity</c:v>
                </c:pt>
                <c:pt idx="15">
                  <c:v>unfolded protein binding</c:v>
                </c:pt>
                <c:pt idx="16">
                  <c:v>protein homodimerization activity</c:v>
                </c:pt>
                <c:pt idx="17">
                  <c:v>metal ion binding</c:v>
                </c:pt>
                <c:pt idx="18">
                  <c:v>cation binding</c:v>
                </c:pt>
                <c:pt idx="19">
                  <c:v>calmodulin-dependent protein kinase activity</c:v>
                </c:pt>
              </c:strCache>
            </c:strRef>
          </c:cat>
          <c:val>
            <c:numRef>
              <c:f>MF!$J$1:$J$20</c:f>
              <c:numCache>
                <c:formatCode>General</c:formatCode>
                <c:ptCount val="20"/>
                <c:pt idx="0">
                  <c:v>0.077276908923643</c:v>
                </c:pt>
                <c:pt idx="1">
                  <c:v>0.059379443004098</c:v>
                </c:pt>
                <c:pt idx="2">
                  <c:v>0.0382202893702434</c:v>
                </c:pt>
                <c:pt idx="3">
                  <c:v>0.0373003261687714</c:v>
                </c:pt>
                <c:pt idx="4">
                  <c:v>0.0257589696412143</c:v>
                </c:pt>
                <c:pt idx="5">
                  <c:v>0.0347077026009869</c:v>
                </c:pt>
                <c:pt idx="6">
                  <c:v>0.0132976499121853</c:v>
                </c:pt>
                <c:pt idx="7">
                  <c:v>0.0400602157731872</c:v>
                </c:pt>
                <c:pt idx="8">
                  <c:v>0.0138830810403947</c:v>
                </c:pt>
                <c:pt idx="9">
                  <c:v>0.0176465668645981</c:v>
                </c:pt>
                <c:pt idx="10">
                  <c:v>0.0151375763151292</c:v>
                </c:pt>
                <c:pt idx="11">
                  <c:v>0.0110395584176633</c:v>
                </c:pt>
                <c:pt idx="12">
                  <c:v>0.0137994480220791</c:v>
                </c:pt>
                <c:pt idx="13">
                  <c:v>0.0112904574726102</c:v>
                </c:pt>
                <c:pt idx="14">
                  <c:v>0.00794513673998494</c:v>
                </c:pt>
                <c:pt idx="15">
                  <c:v>0.00627247637367232</c:v>
                </c:pt>
                <c:pt idx="16">
                  <c:v>0.00752697164840679</c:v>
                </c:pt>
                <c:pt idx="17">
                  <c:v>0.0224136489085891</c:v>
                </c:pt>
                <c:pt idx="18">
                  <c:v>0.00643974241030359</c:v>
                </c:pt>
                <c:pt idx="19">
                  <c:v>0.00342895375094087</c:v>
                </c:pt>
              </c:numCache>
            </c:numRef>
          </c:val>
        </c:ser>
        <c:ser>
          <c:idx val="1"/>
          <c:order val="1"/>
          <c:tx>
            <c:v>ratio in genome</c:v>
          </c:tx>
          <c:invertIfNegative val="0"/>
          <c:cat>
            <c:strRef>
              <c:f>MF!$H$1:$H$20</c:f>
              <c:strCache>
                <c:ptCount val="20"/>
                <c:pt idx="0">
                  <c:v>ATP binding</c:v>
                </c:pt>
                <c:pt idx="1">
                  <c:v>protein binding</c:v>
                </c:pt>
                <c:pt idx="2">
                  <c:v>zinc ion binding</c:v>
                </c:pt>
                <c:pt idx="3">
                  <c:v>nucleotide binding</c:v>
                </c:pt>
                <c:pt idx="4">
                  <c:v>protein serine/threonine kinase activity</c:v>
                </c:pt>
                <c:pt idx="5">
                  <c:v>sequence-specific DNA binding transcription factor activity</c:v>
                </c:pt>
                <c:pt idx="6">
                  <c:v>copper ion binding</c:v>
                </c:pt>
                <c:pt idx="7">
                  <c:v>DNA binding</c:v>
                </c:pt>
                <c:pt idx="8">
                  <c:v>receptor activity</c:v>
                </c:pt>
                <c:pt idx="9">
                  <c:v>electron carrier activity</c:v>
                </c:pt>
                <c:pt idx="10">
                  <c:v>RNA binding</c:v>
                </c:pt>
                <c:pt idx="11">
                  <c:v>calcium ion binding</c:v>
                </c:pt>
                <c:pt idx="12">
                  <c:v>2-alkenal reductase [NAD(P)] activity</c:v>
                </c:pt>
                <c:pt idx="13">
                  <c:v>GTP binding</c:v>
                </c:pt>
                <c:pt idx="14">
                  <c:v>protein tyrosine kinase activity</c:v>
                </c:pt>
                <c:pt idx="15">
                  <c:v>unfolded protein binding</c:v>
                </c:pt>
                <c:pt idx="16">
                  <c:v>protein homodimerization activity</c:v>
                </c:pt>
                <c:pt idx="17">
                  <c:v>metal ion binding</c:v>
                </c:pt>
                <c:pt idx="18">
                  <c:v>cation binding</c:v>
                </c:pt>
                <c:pt idx="19">
                  <c:v>calmodulin-dependent protein kinase activity</c:v>
                </c:pt>
              </c:strCache>
            </c:strRef>
          </c:cat>
          <c:val>
            <c:numRef>
              <c:f>MF!$K$1:$K$20</c:f>
              <c:numCache>
                <c:formatCode>General</c:formatCode>
                <c:ptCount val="20"/>
                <c:pt idx="0">
                  <c:v>0.0500666188377575</c:v>
                </c:pt>
                <c:pt idx="1">
                  <c:v>0.0404325099928257</c:v>
                </c:pt>
                <c:pt idx="2">
                  <c:v>0.024623347340371</c:v>
                </c:pt>
                <c:pt idx="3">
                  <c:v>0.0254945167572</c:v>
                </c:pt>
                <c:pt idx="4">
                  <c:v>0.0172440299272317</c:v>
                </c:pt>
                <c:pt idx="5">
                  <c:v>0.0244952341908373</c:v>
                </c:pt>
                <c:pt idx="6">
                  <c:v>0.00784052475146049</c:v>
                </c:pt>
                <c:pt idx="7">
                  <c:v>0.0301578354002255</c:v>
                </c:pt>
                <c:pt idx="8">
                  <c:v>0.00866044890847596</c:v>
                </c:pt>
                <c:pt idx="9">
                  <c:v>0.0116070513477503</c:v>
                </c:pt>
                <c:pt idx="10">
                  <c:v>0.00971097673465204</c:v>
                </c:pt>
                <c:pt idx="11">
                  <c:v>0.00681561955519114</c:v>
                </c:pt>
                <c:pt idx="12">
                  <c:v>0.0091472788767039</c:v>
                </c:pt>
                <c:pt idx="13">
                  <c:v>0.00717433637388541</c:v>
                </c:pt>
                <c:pt idx="14">
                  <c:v>0.00466331864302552</c:v>
                </c:pt>
                <c:pt idx="15">
                  <c:v>0.00338218714768884</c:v>
                </c:pt>
                <c:pt idx="16">
                  <c:v>0.00427897919442451</c:v>
                </c:pt>
                <c:pt idx="17">
                  <c:v>0.0163728605104028</c:v>
                </c:pt>
                <c:pt idx="18">
                  <c:v>0.00361279081684944</c:v>
                </c:pt>
                <c:pt idx="19">
                  <c:v>0.00161422568412422</c:v>
                </c:pt>
              </c:numCache>
            </c:numRef>
          </c:val>
        </c:ser>
        <c:dLbls>
          <c:showLegendKey val="0"/>
          <c:showVal val="0"/>
          <c:showCatName val="0"/>
          <c:showSerName val="0"/>
          <c:showPercent val="0"/>
          <c:showBubbleSize val="0"/>
        </c:dLbls>
        <c:gapWidth val="150"/>
        <c:axId val="2117274904"/>
        <c:axId val="2117976568"/>
      </c:barChart>
      <c:catAx>
        <c:axId val="2117274904"/>
        <c:scaling>
          <c:orientation val="minMax"/>
        </c:scaling>
        <c:delete val="0"/>
        <c:axPos val="l"/>
        <c:majorTickMark val="out"/>
        <c:minorTickMark val="none"/>
        <c:tickLblPos val="nextTo"/>
        <c:crossAx val="2117976568"/>
        <c:crosses val="autoZero"/>
        <c:auto val="1"/>
        <c:lblAlgn val="ctr"/>
        <c:lblOffset val="100"/>
        <c:noMultiLvlLbl val="0"/>
      </c:catAx>
      <c:valAx>
        <c:axId val="2117976568"/>
        <c:scaling>
          <c:orientation val="minMax"/>
        </c:scaling>
        <c:delete val="0"/>
        <c:axPos val="b"/>
        <c:majorGridlines>
          <c:spPr>
            <a:ln>
              <a:noFill/>
            </a:ln>
          </c:spPr>
        </c:majorGridlines>
        <c:numFmt formatCode="General" sourceLinked="1"/>
        <c:majorTickMark val="out"/>
        <c:minorTickMark val="none"/>
        <c:tickLblPos val="nextTo"/>
        <c:crossAx val="2117274904"/>
        <c:crosses val="autoZero"/>
        <c:crossBetween val="between"/>
      </c:valAx>
    </c:plotArea>
    <c:plotVisOnly val="1"/>
    <c:dispBlanksAs val="gap"/>
    <c:showDLblsOverMax val="0"/>
  </c:chart>
  <c:externalData r:id="rId1">
    <c:autoUpdate val="0"/>
  </c:externalData>
  <c:userShapes r:id="rId2"/>
</c:chartSpace>
</file>

<file path=ppt/drawings/drawing1.xml><?xml version="1.0" encoding="utf-8"?>
<c:userShapes xmlns:c="http://schemas.openxmlformats.org/drawingml/2006/chart">
  <cdr:relSizeAnchor xmlns:cdr="http://schemas.openxmlformats.org/drawingml/2006/chartDrawing">
    <cdr:from>
      <cdr:x>0.64922</cdr:x>
      <cdr:y>0.12626</cdr:y>
    </cdr:from>
    <cdr:to>
      <cdr:x>0.90664</cdr:x>
      <cdr:y>0.23217</cdr:y>
    </cdr:to>
    <cdr:sp macro="" textlink="">
      <cdr:nvSpPr>
        <cdr:cNvPr id="2" name="TextBox 1"/>
        <cdr:cNvSpPr txBox="1"/>
      </cdr:nvSpPr>
      <cdr:spPr>
        <a:xfrm xmlns:a="http://schemas.openxmlformats.org/drawingml/2006/main">
          <a:off x="3974107" y="770456"/>
          <a:ext cx="1575793" cy="646331"/>
        </a:xfrm>
        <a:prstGeom xmlns:a="http://schemas.openxmlformats.org/drawingml/2006/main" prst="rect">
          <a:avLst/>
        </a:prstGeom>
        <a:noFill xmlns:a="http://schemas.openxmlformats.org/drawingml/2006/main"/>
      </cdr:spPr>
      <cdr:txBody>
        <a:bodyPr xmlns:a="http://schemas.openxmlformats.org/drawingml/2006/main" wrap="squar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pPr marL="171450" indent="-171450">
            <a:buFont typeface="Wingdings" charset="0"/>
            <a:buChar char="n"/>
          </a:pPr>
          <a:r>
            <a:rPr lang="en-US" sz="1200" b="1" dirty="0" smtClean="0">
              <a:solidFill>
                <a:srgbClr val="FF6600"/>
              </a:solidFill>
              <a:ea typeface="Wingdings"/>
              <a:cs typeface="Wingdings"/>
              <a:sym typeface="Wingdings"/>
            </a:rPr>
            <a:t> </a:t>
          </a:r>
          <a:r>
            <a:rPr lang="en-US" sz="1200" b="1" dirty="0" smtClean="0">
              <a:ea typeface="Wingdings"/>
              <a:cs typeface="Wingdings"/>
              <a:sym typeface="Wingdings"/>
            </a:rPr>
            <a:t>Ratio</a:t>
          </a:r>
          <a:r>
            <a:rPr lang="en-US" sz="1200" b="1" dirty="0" smtClean="0">
              <a:solidFill>
                <a:schemeClr val="tx1"/>
              </a:solidFill>
              <a:ea typeface="Wingdings"/>
              <a:cs typeface="Wingdings"/>
              <a:sym typeface="Wingdings"/>
            </a:rPr>
            <a:t> in genome</a:t>
          </a:r>
        </a:p>
        <a:p xmlns:a="http://schemas.openxmlformats.org/drawingml/2006/main">
          <a:pPr marL="171450" indent="-171450">
            <a:buFont typeface="Wingdings" charset="0"/>
            <a:buChar char="n"/>
          </a:pPr>
          <a:endParaRPr lang="en-US" sz="1200" b="1" dirty="0">
            <a:solidFill>
              <a:schemeClr val="tx1"/>
            </a:solidFill>
            <a:ea typeface="Wingdings"/>
            <a:cs typeface="Wingdings"/>
            <a:sym typeface="Wingdings"/>
          </a:endParaRPr>
        </a:p>
        <a:p xmlns:a="http://schemas.openxmlformats.org/drawingml/2006/main">
          <a:pPr marL="171450" indent="-171450">
            <a:buFont typeface="Wingdings" charset="0"/>
            <a:buChar char="n"/>
          </a:pPr>
          <a:r>
            <a:rPr lang="en-US" sz="1200" dirty="0" smtClean="0">
              <a:solidFill>
                <a:schemeClr val="tx2">
                  <a:lumMod val="60000"/>
                  <a:lumOff val="40000"/>
                </a:schemeClr>
              </a:solidFill>
              <a:ea typeface="Wingdings"/>
              <a:cs typeface="Wingdings"/>
              <a:sym typeface="Wingdings"/>
            </a:rPr>
            <a:t> </a:t>
          </a:r>
          <a:r>
            <a:rPr lang="en-US" sz="1200" b="1" dirty="0" smtClean="0">
              <a:solidFill>
                <a:schemeClr val="tx1"/>
              </a:solidFill>
              <a:ea typeface="Wingdings"/>
              <a:cs typeface="Wingdings"/>
              <a:sym typeface="Wingdings"/>
            </a:rPr>
            <a:t>Ratio in DE genes</a:t>
          </a:r>
          <a:endParaRPr lang="en-US" sz="1200" b="1" dirty="0" smtClean="0">
            <a:solidFill>
              <a:schemeClr val="tx1"/>
            </a:solidFill>
          </a:endParaRPr>
        </a:p>
      </cdr:txBody>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3C01273F-F4BC-4C44-9788-34192E244855}" type="datetimeFigureOut">
              <a:rPr lang="en-US" smtClean="0"/>
              <a:t>10/1/14</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8F9F143A-5920-AB45-A74D-05287F4F46A2}" type="slidenum">
              <a:rPr lang="en-US" smtClean="0"/>
              <a:t>‹#›</a:t>
            </a:fld>
            <a:endParaRPr lang="en-US"/>
          </a:p>
        </p:txBody>
      </p:sp>
    </p:spTree>
    <p:extLst>
      <p:ext uri="{BB962C8B-B14F-4D97-AF65-F5344CB8AC3E}">
        <p14:creationId xmlns:p14="http://schemas.microsoft.com/office/powerpoint/2010/main" val="1893613041"/>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7386FD56-43BD-C649-A160-981ABCB2D949}" type="slidenum">
              <a:rPr lang="en-US" smtClean="0"/>
              <a:t>1</a:t>
            </a:fld>
            <a:endParaRPr lang="en-US"/>
          </a:p>
        </p:txBody>
      </p:sp>
    </p:spTree>
    <p:extLst>
      <p:ext uri="{BB962C8B-B14F-4D97-AF65-F5344CB8AC3E}">
        <p14:creationId xmlns:p14="http://schemas.microsoft.com/office/powerpoint/2010/main" val="372737988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2E796BE3-420F-8F41-9769-130A60F9F022}" type="datetimeFigureOut">
              <a:rPr lang="en-US" smtClean="0"/>
              <a:t>10/1/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7339820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E796BE3-420F-8F41-9769-130A60F9F022}" type="datetimeFigureOut">
              <a:rPr lang="en-US" smtClean="0"/>
              <a:t>10/1/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1708517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E796BE3-420F-8F41-9769-130A60F9F022}" type="datetimeFigureOut">
              <a:rPr lang="en-US" smtClean="0"/>
              <a:t>10/1/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42401161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E796BE3-420F-8F41-9769-130A60F9F022}" type="datetimeFigureOut">
              <a:rPr lang="en-US" smtClean="0"/>
              <a:t>10/1/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4317027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2E796BE3-420F-8F41-9769-130A60F9F022}" type="datetimeFigureOut">
              <a:rPr lang="en-US" smtClean="0"/>
              <a:t>10/1/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7275600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2E796BE3-420F-8F41-9769-130A60F9F022}" type="datetimeFigureOut">
              <a:rPr lang="en-US" smtClean="0"/>
              <a:t>10/1/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17447378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2E796BE3-420F-8F41-9769-130A60F9F022}" type="datetimeFigureOut">
              <a:rPr lang="en-US" smtClean="0"/>
              <a:t>10/1/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1078383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2E796BE3-420F-8F41-9769-130A60F9F022}" type="datetimeFigureOut">
              <a:rPr lang="en-US" smtClean="0"/>
              <a:t>10/1/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6143082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E796BE3-420F-8F41-9769-130A60F9F022}" type="datetimeFigureOut">
              <a:rPr lang="en-US" smtClean="0"/>
              <a:t>10/1/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15363767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E796BE3-420F-8F41-9769-130A60F9F022}" type="datetimeFigureOut">
              <a:rPr lang="en-US" smtClean="0"/>
              <a:t>10/1/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33622466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E796BE3-420F-8F41-9769-130A60F9F022}" type="datetimeFigureOut">
              <a:rPr lang="en-US" smtClean="0"/>
              <a:t>10/1/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1669008522"/>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E796BE3-420F-8F41-9769-130A60F9F022}" type="datetimeFigureOut">
              <a:rPr lang="en-US" smtClean="0"/>
              <a:t>10/1/14</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48DDB1A-797B-A449-B09E-F7DFAE71F05F}" type="slidenum">
              <a:rPr lang="en-US" smtClean="0"/>
              <a:t>‹#›</a:t>
            </a:fld>
            <a:endParaRPr lang="en-US"/>
          </a:p>
        </p:txBody>
      </p:sp>
    </p:spTree>
    <p:extLst>
      <p:ext uri="{BB962C8B-B14F-4D97-AF65-F5344CB8AC3E}">
        <p14:creationId xmlns:p14="http://schemas.microsoft.com/office/powerpoint/2010/main" val="53507859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6.xml"/><Relationship Id="rId2" Type="http://schemas.openxmlformats.org/officeDocument/2006/relationships/notesSlide" Target="../notesSlides/notesSlide1.xml"/><Relationship Id="rId3" Type="http://schemas.openxmlformats.org/officeDocument/2006/relationships/chart" Target="../charts/char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title"/>
          </p:nvPr>
        </p:nvSpPr>
        <p:spPr>
          <a:xfrm>
            <a:off x="429400" y="5511800"/>
            <a:ext cx="8333600" cy="1231899"/>
          </a:xfrm>
        </p:spPr>
        <p:txBody>
          <a:bodyPr>
            <a:noAutofit/>
          </a:bodyPr>
          <a:lstStyle/>
          <a:p>
            <a:pPr algn="l"/>
            <a:r>
              <a:rPr lang="en-US" sz="1200" b="1" dirty="0" smtClean="0"/>
              <a:t>Figure </a:t>
            </a:r>
            <a:r>
              <a:rPr lang="en-US" sz="1200" b="1" dirty="0"/>
              <a:t>S3. Top twenty over-represented GO terms for molecular functions in differentially expressed (DE) photoperiod genes. </a:t>
            </a:r>
            <a:r>
              <a:rPr lang="en-US" sz="1200" dirty="0"/>
              <a:t>GO terms involved with DE genes between long- and short-day </a:t>
            </a:r>
            <a:r>
              <a:rPr lang="en-US" sz="1200" dirty="0" smtClean="0"/>
              <a:t>treatments </a:t>
            </a:r>
            <a:r>
              <a:rPr lang="en-US" sz="1200" dirty="0"/>
              <a:t>were analyzed with </a:t>
            </a:r>
            <a:r>
              <a:rPr lang="en-US" sz="1200" dirty="0" err="1"/>
              <a:t>Goseq</a:t>
            </a:r>
            <a:r>
              <a:rPr lang="en-US" sz="1200" dirty="0"/>
              <a:t> [61] to compare their enrichment in DE genes compared with whole genome. The p-value was adjusted with BH </a:t>
            </a:r>
            <a:r>
              <a:rPr lang="en-US" sz="1200"/>
              <a:t>method </a:t>
            </a:r>
            <a:r>
              <a:rPr lang="en-US" sz="1200"/>
              <a:t>[</a:t>
            </a:r>
            <a:r>
              <a:rPr lang="en-US" sz="1200" smtClean="0"/>
              <a:t>95].</a:t>
            </a:r>
            <a:r>
              <a:rPr lang="en-US" sz="1200" dirty="0"/>
              <a:t>The over-represented genes were defined with adjusted p-value smaller than 0.05. The ratio of each GO term is calculated by comparing the number of genes involved with each GO term with number of genes in the whole group. </a:t>
            </a:r>
          </a:p>
        </p:txBody>
      </p:sp>
      <p:graphicFrame>
        <p:nvGraphicFramePr>
          <p:cNvPr id="4" name="Chart 3"/>
          <p:cNvGraphicFramePr>
            <a:graphicFrameLocks/>
          </p:cNvGraphicFramePr>
          <p:nvPr>
            <p:extLst>
              <p:ext uri="{D42A27DB-BD31-4B8C-83A1-F6EECF244321}">
                <p14:modId xmlns:p14="http://schemas.microsoft.com/office/powerpoint/2010/main" val="2991851610"/>
              </p:ext>
            </p:extLst>
          </p:nvPr>
        </p:nvGraphicFramePr>
        <p:xfrm>
          <a:off x="977900" y="0"/>
          <a:ext cx="6121400" cy="6102350"/>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1599061159"/>
      </p:ext>
    </p:extLst>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335</TotalTime>
  <Words>122</Words>
  <Application>Microsoft Macintosh PowerPoint</Application>
  <PresentationFormat>On-screen Show (4:3)</PresentationFormat>
  <Paragraphs>5</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Figure S3. Top twenty over-represented GO terms for molecular functions in differentially expressed (DE) photoperiod genes. GO terms involved with DE genes between long- and short-day treatments were analyzed with Goseq [61] to compare their enrichment in DE genes compared with whole genome. The p-value was adjusted with BH method [95].The over-represented genes were defined with adjusted p-value smaller than 0.05. The ratio of each GO term is calculated by comparing the number of genes involved with each GO term with number of genes in the whole group. </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s</dc:title>
  <dc:creator>Tian Lin</dc:creator>
  <cp:lastModifiedBy/>
  <cp:revision>26</cp:revision>
  <dcterms:created xsi:type="dcterms:W3CDTF">2014-05-27T17:03:52Z</dcterms:created>
  <dcterms:modified xsi:type="dcterms:W3CDTF">2014-10-01T20:07:34Z</dcterms:modified>
</cp:coreProperties>
</file>